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1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877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33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085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9170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0470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573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0521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8982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5772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5808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6008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B5A70-FB36-4C56-AA72-06F1F156BDCC}" type="datetimeFigureOut">
              <a:rPr lang="de-DE" smtClean="0"/>
              <a:t>26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109D5-C541-4AC4-BC20-AE3C4A585B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7626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ieren 14"/>
          <p:cNvGrpSpPr/>
          <p:nvPr/>
        </p:nvGrpSpPr>
        <p:grpSpPr>
          <a:xfrm>
            <a:off x="32671" y="675514"/>
            <a:ext cx="6494025" cy="4434331"/>
            <a:chOff x="539552" y="675514"/>
            <a:chExt cx="6494025" cy="4434331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552" y="675514"/>
              <a:ext cx="6494025" cy="4434331"/>
            </a:xfrm>
            <a:prstGeom prst="rect">
              <a:avLst/>
            </a:prstGeom>
            <a:noFill/>
          </p:spPr>
        </p:pic>
        <p:sp>
          <p:nvSpPr>
            <p:cNvPr id="5" name="Rechteck 4"/>
            <p:cNvSpPr/>
            <p:nvPr/>
          </p:nvSpPr>
          <p:spPr>
            <a:xfrm>
              <a:off x="1043608" y="1005136"/>
              <a:ext cx="72008" cy="12961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" name="Rechteck 5"/>
            <p:cNvSpPr/>
            <p:nvPr/>
          </p:nvSpPr>
          <p:spPr>
            <a:xfrm>
              <a:off x="4023956" y="1031287"/>
              <a:ext cx="144016" cy="12961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" name="Rechteck 6"/>
            <p:cNvSpPr/>
            <p:nvPr/>
          </p:nvSpPr>
          <p:spPr>
            <a:xfrm>
              <a:off x="3995936" y="3302958"/>
              <a:ext cx="144016" cy="12961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Rechteck 7"/>
            <p:cNvSpPr/>
            <p:nvPr/>
          </p:nvSpPr>
          <p:spPr>
            <a:xfrm>
              <a:off x="715632" y="3192586"/>
              <a:ext cx="144016" cy="12961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146891" y="3792195"/>
              <a:ext cx="11785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ardiac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Index (L/min/m</a:t>
              </a:r>
              <a:r>
                <a:rPr lang="de-DE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 rot="16200000">
              <a:off x="3633337" y="1579331"/>
              <a:ext cx="9252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Heart Rate 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1/min)</a:t>
              </a:r>
              <a:endParaRPr lang="de-DE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3406545" y="3851002"/>
              <a:ext cx="13227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Strok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Volume Index (ml/m</a:t>
              </a:r>
              <a:r>
                <a:rPr lang="de-DE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hteck 13"/>
            <p:cNvSpPr/>
            <p:nvPr/>
          </p:nvSpPr>
          <p:spPr>
            <a:xfrm>
              <a:off x="664146" y="999175"/>
              <a:ext cx="144016" cy="12961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" name="Textfeld 11"/>
            <p:cNvSpPr txBox="1"/>
            <p:nvPr/>
          </p:nvSpPr>
          <p:spPr>
            <a:xfrm rot="16200000">
              <a:off x="-18977" y="1579332"/>
              <a:ext cx="1454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ean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rterial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ressur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mHg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130971" y="5157243"/>
            <a:ext cx="8761509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Spaghetti plots for cardiovascular variables. The figure illustrates the changes in cardiovascular variables during analgesic treatment for each patient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ly.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 Spaghetti plot for mean arterial pressure (MAP)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 Spaghetti plot for heart rate (HR)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 Spaghetti plot for cardiac index (CI)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 Spaghetti plot for stoke volume index (SVI)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/>
          </a:p>
        </p:txBody>
      </p:sp>
      <p:sp>
        <p:nvSpPr>
          <p:cNvPr id="3" name="Textfeld 2"/>
          <p:cNvSpPr txBox="1"/>
          <p:nvPr/>
        </p:nvSpPr>
        <p:spPr>
          <a:xfrm>
            <a:off x="84084" y="491392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3471716" y="267823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489055" y="491392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94942" y="267823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696" y="740330"/>
            <a:ext cx="2564556" cy="481802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/>
          <a:srcRect l="15649" t="31761" r="20033" b="34144"/>
          <a:stretch/>
        </p:blipFill>
        <p:spPr>
          <a:xfrm>
            <a:off x="329301" y="671378"/>
            <a:ext cx="2675770" cy="2006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897462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Bildschirmpräsentatio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Application Hosting Platfor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öser, Benjamin Lothar</dc:creator>
  <cp:lastModifiedBy>Löser, Benjamin Lothar</cp:lastModifiedBy>
  <cp:revision>13</cp:revision>
  <dcterms:created xsi:type="dcterms:W3CDTF">2020-07-06T16:11:11Z</dcterms:created>
  <dcterms:modified xsi:type="dcterms:W3CDTF">2020-07-26T14:58:36Z</dcterms:modified>
</cp:coreProperties>
</file>